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2"/>
  </p:handoutMasterIdLst>
  <p:sldIdLst>
    <p:sldId id="269" r:id="rId4"/>
    <p:sldId id="264" r:id="rId5"/>
    <p:sldId id="266" r:id="rId6"/>
    <p:sldId id="267" r:id="rId7"/>
    <p:sldId id="268" r:id="rId8"/>
    <p:sldId id="270" r:id="rId9"/>
    <p:sldId id="265" r:id="rId10"/>
    <p:sldId id="271" r:id="rId11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1196" y="6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ags" Target="tags/tag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1/20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76200" y="1219201"/>
            <a:ext cx="8991600" cy="1143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r>
              <a:rPr lang="nl-NL" sz="2800" dirty="0"/>
              <a:t>Standardized Uptake Values in FDG PET/CT for Prosthetic Heart Valve Endocarditis</a:t>
            </a:r>
            <a:r>
              <a:rPr lang="nl-NL" sz="2800" dirty="0" smtClean="0"/>
              <a:t>: A </a:t>
            </a:r>
            <a:r>
              <a:rPr lang="nl-NL" sz="2800" dirty="0"/>
              <a:t>Call for </a:t>
            </a:r>
            <a:r>
              <a:rPr lang="nl-NL" sz="2800" dirty="0" smtClean="0"/>
              <a:t>Standardization</a:t>
            </a:r>
            <a:endParaRPr lang="en-US" altLang="en-US" sz="2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143000"/>
          </a:xfrm>
          <a:ln>
            <a:noFill/>
            <a:miter lim="800000"/>
            <a:headEnd/>
            <a:tailEnd/>
          </a:ln>
        </p:spPr>
        <p:txBody>
          <a:bodyPr anchor="t"/>
          <a:lstStyle/>
          <a:p>
            <a:pPr>
              <a:spcAft>
                <a:spcPts val="0"/>
              </a:spcAft>
            </a:pP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AM Scholtens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, LE Swart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6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, HJ te Kolste</a:t>
            </a:r>
            <a:r>
              <a:rPr lang="en-GB" sz="1600" baseline="300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6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HJ </a:t>
            </a:r>
            <a:r>
              <a:rPr lang="en-GB" sz="16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Verberne</a:t>
            </a:r>
            <a:r>
              <a:rPr lang="en-GB" sz="1600" baseline="300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16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RPJ Budde</a:t>
            </a:r>
            <a:r>
              <a:rPr lang="en-GB" sz="1600" baseline="30000" dirty="0"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ea typeface="Times New Roman" panose="02020603050405020304" pitchFamily="18" charset="0"/>
                <a:cs typeface="Times New Roman" panose="02020603050405020304" pitchFamily="18" charset="0"/>
              </a:rPr>
              <a:t>, MGEH </a:t>
            </a:r>
            <a:r>
              <a:rPr lang="en-GB" sz="16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Lam</a:t>
            </a:r>
            <a:r>
              <a:rPr lang="en-GB" sz="1600" baseline="30000" dirty="0" smtClean="0"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GB" sz="1600" dirty="0">
              <a:ea typeface="Times New Roman" panose="02020603050405020304" pitchFamily="18" charset="0"/>
            </a:endParaRPr>
          </a:p>
          <a:p>
            <a:r>
              <a:rPr lang="en-GB" sz="1100" baseline="30000" dirty="0"/>
              <a:t>1</a:t>
            </a:r>
            <a:r>
              <a:rPr lang="en-GB" sz="1100" dirty="0"/>
              <a:t>: Meander Medical </a:t>
            </a:r>
            <a:r>
              <a:rPr lang="en-GB" sz="1100" dirty="0" err="1"/>
              <a:t>Center</a:t>
            </a:r>
            <a:r>
              <a:rPr lang="en-GB" sz="1100" dirty="0"/>
              <a:t>, Amersfoort, the Netherlands	</a:t>
            </a:r>
          </a:p>
          <a:p>
            <a:r>
              <a:rPr lang="en-GB" sz="1100" baseline="30000" dirty="0"/>
              <a:t>2</a:t>
            </a:r>
            <a:r>
              <a:rPr lang="en-GB" sz="1100" dirty="0"/>
              <a:t>: Erasmus Medical </a:t>
            </a:r>
            <a:r>
              <a:rPr lang="en-GB" sz="1100" dirty="0" err="1"/>
              <a:t>Center</a:t>
            </a:r>
            <a:r>
              <a:rPr lang="en-GB" sz="1100" dirty="0"/>
              <a:t>, Rotterdam, the Netherlands	</a:t>
            </a:r>
          </a:p>
          <a:p>
            <a:r>
              <a:rPr lang="en-GB" sz="1100" baseline="30000" dirty="0" smtClean="0"/>
              <a:t>3</a:t>
            </a:r>
            <a:r>
              <a:rPr lang="en-GB" sz="1100" dirty="0" smtClean="0"/>
              <a:t>: VU Medical </a:t>
            </a:r>
            <a:r>
              <a:rPr lang="en-GB" sz="1100" dirty="0" err="1" smtClean="0"/>
              <a:t>Center</a:t>
            </a:r>
            <a:r>
              <a:rPr lang="en-GB" sz="1100" dirty="0" smtClean="0"/>
              <a:t>, Amsterdam, the Netherlands            </a:t>
            </a:r>
            <a:r>
              <a:rPr lang="en-GB" sz="1100" dirty="0" smtClean="0">
                <a:solidFill>
                  <a:schemeClr val="bg1"/>
                </a:solidFill>
              </a:rPr>
              <a:t>.</a:t>
            </a:r>
            <a:endParaRPr lang="en-GB" sz="1100" baseline="30000" dirty="0" smtClean="0">
              <a:solidFill>
                <a:schemeClr val="bg1"/>
              </a:solidFill>
            </a:endParaRPr>
          </a:p>
          <a:p>
            <a:r>
              <a:rPr lang="en-GB" sz="1100" baseline="30000" dirty="0" smtClean="0"/>
              <a:t>4</a:t>
            </a:r>
            <a:r>
              <a:rPr lang="en-GB" sz="1100" dirty="0" smtClean="0"/>
              <a:t>: </a:t>
            </a:r>
            <a:r>
              <a:rPr lang="en-GB" sz="1100" dirty="0"/>
              <a:t>Academic Medical </a:t>
            </a:r>
            <a:r>
              <a:rPr lang="en-GB" sz="1100" dirty="0" err="1"/>
              <a:t>Center</a:t>
            </a:r>
            <a:r>
              <a:rPr lang="en-GB" sz="1100" dirty="0"/>
              <a:t>, Amsterdam, the Netherlands	</a:t>
            </a:r>
          </a:p>
          <a:p>
            <a:r>
              <a:rPr lang="en-GB" sz="1100" baseline="30000" dirty="0" smtClean="0"/>
              <a:t>5</a:t>
            </a:r>
            <a:r>
              <a:rPr lang="en-GB" sz="1100" dirty="0" smtClean="0"/>
              <a:t>: </a:t>
            </a:r>
            <a:r>
              <a:rPr lang="en-GB" sz="1100" dirty="0"/>
              <a:t>University Medical </a:t>
            </a:r>
            <a:r>
              <a:rPr lang="en-GB" sz="1100" dirty="0" err="1"/>
              <a:t>Center</a:t>
            </a:r>
            <a:r>
              <a:rPr lang="en-GB" sz="1100" dirty="0"/>
              <a:t> Utrecht, the Netherlands	</a:t>
            </a:r>
          </a:p>
          <a:p>
            <a:endParaRPr lang="en-US" altLang="en-US" sz="16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Afbeelding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17936" y="3886200"/>
            <a:ext cx="2535464" cy="15240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5617936" y="3879706"/>
            <a:ext cx="2535464" cy="152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6" name="Afbeelding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0424" y="3879706"/>
            <a:ext cx="1030398" cy="153049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224277" y="3879706"/>
            <a:ext cx="1026545" cy="152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7193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FDG PET/CT is increasingly used in prosthetic heart valve endocarditis (PVE). </a:t>
            </a:r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altLang="en-US" sz="2800" dirty="0" smtClean="0"/>
              <a:t>FDG PET/CT allows for semi-quantitative measurement of glucose metabolism in standardized uptake values (SUV).</a:t>
            </a:r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The value of SUV in PVE is as yet uncertain</a:t>
            </a:r>
            <a:r>
              <a:rPr lang="en-US" altLang="en-US" sz="2800" dirty="0"/>
              <a:t>.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T</a:t>
            </a:r>
            <a:r>
              <a:rPr lang="en-US" altLang="en-US" sz="2800" dirty="0" smtClean="0"/>
              <a:t>ype:</a:t>
            </a:r>
          </a:p>
          <a:p>
            <a:pPr marL="400050" lvl="1" indent="0">
              <a:buNone/>
            </a:pPr>
            <a:r>
              <a:rPr lang="en-US" altLang="en-US" sz="2000" dirty="0"/>
              <a:t>	</a:t>
            </a:r>
            <a:r>
              <a:rPr lang="en-US" altLang="en-US" sz="2400" dirty="0" smtClean="0"/>
              <a:t>Review of the available literature on SUV in PVE</a:t>
            </a:r>
          </a:p>
          <a:p>
            <a:pPr marL="400050" lvl="1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800" dirty="0" smtClean="0"/>
              <a:t>Included studies</a:t>
            </a:r>
            <a:r>
              <a:rPr lang="en-US" altLang="en-US" sz="2800" dirty="0" smtClean="0"/>
              <a:t>:</a:t>
            </a:r>
          </a:p>
          <a:p>
            <a:pPr marL="400050" lvl="1" indent="0">
              <a:buNone/>
            </a:pPr>
            <a:r>
              <a:rPr lang="en-US" altLang="en-US" sz="2400" dirty="0"/>
              <a:t>	</a:t>
            </a:r>
            <a:r>
              <a:rPr lang="en-US" altLang="en-US" sz="2400" dirty="0" smtClean="0"/>
              <a:t>Studies reporting SUV in PHV patients in relation to 	final diagnosis of PVE (definite/possible/rejected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Tx/>
              <a:buChar char="-"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>
              <a:buFontTx/>
              <a:buChar char="-"/>
            </a:pPr>
            <a:r>
              <a:rPr lang="en-US" altLang="en-US" sz="2800" dirty="0" smtClean="0">
                <a:solidFill>
                  <a:srgbClr val="000000"/>
                </a:solidFill>
              </a:rPr>
              <a:t>8 eligible studies</a:t>
            </a:r>
          </a:p>
          <a:p>
            <a:pPr>
              <a:buFontTx/>
              <a:buChar char="-"/>
            </a:pPr>
            <a:endParaRPr lang="en-US" altLang="en-US" sz="2800" dirty="0">
              <a:solidFill>
                <a:srgbClr val="000000"/>
              </a:solidFill>
            </a:endParaRPr>
          </a:p>
          <a:p>
            <a:pPr>
              <a:buFontTx/>
              <a:buChar char="-"/>
            </a:pPr>
            <a:r>
              <a:rPr lang="en-US" altLang="en-US" sz="2800" dirty="0" smtClean="0">
                <a:solidFill>
                  <a:srgbClr val="000000"/>
                </a:solidFill>
              </a:rPr>
              <a:t>Large variation in acquisition, reconstruction and measurement parameters</a:t>
            </a:r>
          </a:p>
          <a:p>
            <a:pPr>
              <a:buFontTx/>
              <a:buChar char="-"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>
              <a:buFontTx/>
              <a:buChar char="-"/>
            </a:pPr>
            <a:r>
              <a:rPr lang="en-US" altLang="en-US" sz="2800" dirty="0" smtClean="0">
                <a:solidFill>
                  <a:srgbClr val="000000"/>
                </a:solidFill>
              </a:rPr>
              <a:t>Large variation in reported SUVs with overlap</a:t>
            </a:r>
          </a:p>
          <a:p>
            <a:pPr marL="0" indent="0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graphicFrame>
        <p:nvGraphicFramePr>
          <p:cNvPr id="2" name="Content Placeholder 1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90764322"/>
              </p:ext>
            </p:extLst>
          </p:nvPr>
        </p:nvGraphicFramePr>
        <p:xfrm>
          <a:off x="457200" y="1639024"/>
          <a:ext cx="8305799" cy="424536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3000"/>
                <a:gridCol w="533400"/>
                <a:gridCol w="509336"/>
                <a:gridCol w="446448"/>
                <a:gridCol w="1292840"/>
                <a:gridCol w="790586"/>
                <a:gridCol w="827790"/>
                <a:gridCol w="1292840"/>
                <a:gridCol w="631360"/>
                <a:gridCol w="838199"/>
              </a:tblGrid>
              <a:tr h="433216"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tudy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Year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atients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Valves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atient preparation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FDG dose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Time to acquisition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Reconstruction method reported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EARL accredited site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amera type</a:t>
                      </a:r>
                      <a:endParaRPr lang="nl-NL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L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0000"/>
                    </a:solidFill>
                  </a:tcPr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Mathieu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7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51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54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 hr fast*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 MBq/kg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0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"3-dimensional time-of-flight ordered-subsets expectation maximization"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yes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GE Discovery 690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>
                    <a:lnT w="12700" cap="flat" cmpd="sng" algn="ctr">
                      <a:solidFill>
                        <a:srgbClr val="C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Jiménez-Ballvé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6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1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2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8 hr HFLC diet, 12 hr fast, 50 IU/kg heparin pre-administratio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5 MBq/kg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5 to 60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"iterative reconstruction"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Siemens Biograph 6 TruePoint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Salomäki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5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3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16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>
                          <a:effectLst/>
                        </a:rPr>
                        <a:t>24 hr LC diet, 10 hr fast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mean 280 MBq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mean 72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Ordered subset expectation maximizatio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yes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GE Discovery VCT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  <a:tr h="230551">
                <a:tc rowSpan="2"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Fagman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5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30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30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</a:rPr>
                        <a:t>HFLC meal, 18 hr fast (n=11)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 MBq/kg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0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"default iterative"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yes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Siemens Biograph TruePoint 64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  <a:tr h="230551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nl-NL" sz="900" u="none" strike="noStrike">
                          <a:effectLst/>
                        </a:rPr>
                        <a:t>6 hr fast (n=19)†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Pizzi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5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92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5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12 hr fast, 50 IU/kg heparin pre-administratio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3.7 MBq/kg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0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Iterative TrueX + Time of Fligh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Siemens Biograph mCT 64S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Rouzet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4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39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5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>
                          <a:effectLst/>
                        </a:rPr>
                        <a:t>HFLC meal, 12 hr fast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4 MBq/kg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0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"iterative 3-dimensional reconstruction algorithm of the system software"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yes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GE Discovery 690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Bartoletti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4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t reported</a:t>
                      </a:r>
                      <a:endParaRPr lang="nl-NL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t reported</a:t>
                      </a:r>
                      <a:endParaRPr lang="nl-NL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t reported</a:t>
                      </a:r>
                      <a:endParaRPr lang="nl-NL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t reported</a:t>
                      </a:r>
                      <a:endParaRPr lang="nl-NL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t reported</a:t>
                      </a:r>
                      <a:endParaRPr lang="nl-NL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  <a:tr h="458114">
                <a:tc>
                  <a:txBody>
                    <a:bodyPr/>
                    <a:lstStyle/>
                    <a:p>
                      <a:pPr algn="l" fontAlgn="ctr"/>
                      <a:r>
                        <a:rPr lang="nl-NL" sz="900" u="none" strike="noStrike">
                          <a:effectLst/>
                        </a:rPr>
                        <a:t>Saby et al.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2013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72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72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u="none" strike="noStrike">
                          <a:effectLst/>
                        </a:rPr>
                        <a:t>HFLC meal, 12 hr fast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5 MBq/kg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60 mi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Ordered subset expectation maximization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>
                          <a:effectLst/>
                        </a:rPr>
                        <a:t>no</a:t>
                      </a:r>
                      <a:endParaRPr lang="nl-NL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l-NL" sz="900" u="none" strike="noStrike" dirty="0">
                          <a:effectLst/>
                        </a:rPr>
                        <a:t>GE Discovery ST</a:t>
                      </a:r>
                      <a:endParaRPr lang="nl-NL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79" marR="4979" marT="4979" marB="0" anchor="ctr"/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pic>
        <p:nvPicPr>
          <p:cNvPr id="2" name="Content Placeholder 1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" y="1905000"/>
            <a:ext cx="9144000" cy="32004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908139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endParaRPr lang="en-GB" sz="1200" dirty="0" smtClean="0"/>
          </a:p>
          <a:p>
            <a:pPr marL="0" indent="0" algn="just">
              <a:buNone/>
            </a:pPr>
            <a:r>
              <a:rPr lang="en-GB" sz="2600" dirty="0" smtClean="0"/>
              <a:t>SUVs reported in the current literature on FDG PET/CT in PVE vary due to different acquisition, reconstruction and measurement methods. </a:t>
            </a:r>
          </a:p>
          <a:p>
            <a:pPr marL="0" indent="0" algn="just">
              <a:buNone/>
            </a:pPr>
            <a:endParaRPr lang="en-GB" sz="2600" dirty="0" smtClean="0"/>
          </a:p>
          <a:p>
            <a:pPr marL="0" indent="0" algn="just">
              <a:buNone/>
            </a:pPr>
            <a:r>
              <a:rPr lang="en-GB" sz="2600" dirty="0" smtClean="0"/>
              <a:t>Standardized measurements on EARL accredited reconstructions seem a sensible and feasible starting point</a:t>
            </a:r>
            <a:r>
              <a:rPr lang="en-GB" sz="2600" dirty="0"/>
              <a:t> for a uniform protocol to allow for better comparison of results between different centres</a:t>
            </a:r>
            <a:r>
              <a:rPr lang="en-GB" sz="2600" dirty="0" smtClean="0"/>
              <a:t>.</a:t>
            </a:r>
            <a:r>
              <a:rPr lang="en-US" altLang="en-US" sz="2600" dirty="0" smtClean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COMMENDATION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648200" y="1524000"/>
            <a:ext cx="4114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GB" sz="2000" dirty="0"/>
              <a:t>Example of proposed measurement </a:t>
            </a:r>
            <a:r>
              <a:rPr lang="en-GB" sz="2000" dirty="0" smtClean="0"/>
              <a:t>standardization </a:t>
            </a:r>
            <a:r>
              <a:rPr lang="en-GB" sz="2000" dirty="0"/>
              <a:t>in a mitral valve prosthesis. </a:t>
            </a:r>
            <a:endParaRPr lang="en-GB" sz="2000" dirty="0" smtClean="0"/>
          </a:p>
          <a:p>
            <a:pPr marL="0" indent="0" algn="ctr">
              <a:buNone/>
            </a:pPr>
            <a:r>
              <a:rPr lang="en-GB" sz="1900" dirty="0" smtClean="0"/>
              <a:t>Fused </a:t>
            </a:r>
            <a:r>
              <a:rPr lang="en-GB" sz="1900" dirty="0"/>
              <a:t>PET/CT images (upper row) and corresponding attenuation corrected PET images (below) showing whole-valve measurement VOI (in this case a self-expanding VOI set to include voxels </a:t>
            </a:r>
            <a:r>
              <a:rPr lang="en-GB" sz="1900" dirty="0"/>
              <a:t>≥</a:t>
            </a:r>
            <a:r>
              <a:rPr lang="en-GB" sz="1900" dirty="0"/>
              <a:t>40% of maximum) and VOI sphere in the descending aorta (lower right). Uptake in myocardium (hardly present here) and the aortic wall are excluded.</a:t>
            </a:r>
            <a:endParaRPr lang="nl-NL" sz="1900" dirty="0">
              <a:effectLst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4175" y="1517584"/>
            <a:ext cx="4346058" cy="43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54590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Words>647</Words>
  <Application>Microsoft Office PowerPoint</Application>
  <PresentationFormat>On-screen Show (4:3)</PresentationFormat>
  <Paragraphs>14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8</vt:i4>
      </vt:variant>
    </vt:vector>
  </HeadingPairs>
  <TitlesOfParts>
    <vt:vector size="17" baseType="lpstr">
      <vt:lpstr>MS PGothic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Standardized Uptake Values in FDG PET/CT for Prosthetic Heart Valve Endocarditis: A Call for Standardization</vt:lpstr>
      <vt:lpstr>BACKGROUND</vt:lpstr>
      <vt:lpstr>METHODS</vt:lpstr>
      <vt:lpstr>RESULTS</vt:lpstr>
      <vt:lpstr>RESULTS</vt:lpstr>
      <vt:lpstr>RESULTS</vt:lpstr>
      <vt:lpstr>CONCLUSION</vt:lpstr>
      <vt:lpstr>RECOMMEND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sbjørn Scholtens</cp:lastModifiedBy>
  <cp:revision>102</cp:revision>
  <dcterms:created xsi:type="dcterms:W3CDTF">2011-04-18T21:44:13Z</dcterms:created>
  <dcterms:modified xsi:type="dcterms:W3CDTF">2017-05-01T12:17:42Z</dcterms:modified>
</cp:coreProperties>
</file>